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4989513" cy="41290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563840" y="1142640"/>
            <a:ext cx="373032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2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113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0C687F2-CC16-47C8-91D7-423DCD2F2F32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sldImg"/>
          </p:nvPr>
        </p:nvSpPr>
        <p:spPr>
          <a:xfrm>
            <a:off x="1563840" y="1143000"/>
            <a:ext cx="3730320" cy="3086280"/>
          </a:xfrm>
          <a:prstGeom prst="rect">
            <a:avLst/>
          </a:prstGeom>
          <a:ln w="0">
            <a:noFill/>
          </a:ln>
        </p:spPr>
      </p:sp>
      <p:sp>
        <p:nvSpPr>
          <p:cNvPr id="73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113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9193D7-A6F3-4D18-873F-A1F95EC1FEC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32F093-AC36-438A-8652-6795B328011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219240"/>
            <a:ext cx="4303440" cy="79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2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1098720"/>
            <a:ext cx="4303440" cy="124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2467800"/>
            <a:ext cx="4303440" cy="124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6C2EE4-A512-4640-A6C3-F93BDE4A94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219240"/>
            <a:ext cx="4303440" cy="79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2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1098720"/>
            <a:ext cx="2099880" cy="124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548440" y="1098720"/>
            <a:ext cx="2099880" cy="124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2467800"/>
            <a:ext cx="2099880" cy="124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548440" y="2467800"/>
            <a:ext cx="2099880" cy="124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16CC5E-DD34-41A9-B770-2506A55543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219240"/>
            <a:ext cx="4303440" cy="79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2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1098720"/>
            <a:ext cx="1385640" cy="124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798560" y="1098720"/>
            <a:ext cx="1385640" cy="124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253680" y="1098720"/>
            <a:ext cx="1385640" cy="124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2467800"/>
            <a:ext cx="1385640" cy="124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798560" y="2467800"/>
            <a:ext cx="1385640" cy="124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253680" y="2467800"/>
            <a:ext cx="1385640" cy="124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17D0A1-113F-4427-AAFB-31D43FADB81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219240"/>
            <a:ext cx="4303440" cy="79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2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1098720"/>
            <a:ext cx="4303440" cy="2620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550"/>
              </a:spcBef>
              <a:buNone/>
              <a:tabLst>
                <a:tab algn="l" pos="0"/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BD4B99-77C3-48E4-8A18-6AB3C1B6FC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219240"/>
            <a:ext cx="4303440" cy="79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2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1098720"/>
            <a:ext cx="4303440" cy="2620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D0DB71-7453-40D1-8976-BC99EA2949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219240"/>
            <a:ext cx="4303440" cy="79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2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1098720"/>
            <a:ext cx="2099880" cy="2620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548440" y="1098720"/>
            <a:ext cx="2099880" cy="2620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8BF8CD-1FF7-4F1A-A184-9F1262CE88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219240"/>
            <a:ext cx="4303440" cy="79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2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F3A637-B09A-4305-A7C3-E4C2BDF02B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219240"/>
            <a:ext cx="4303440" cy="3702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550"/>
              </a:spcBef>
              <a:tabLst>
                <a:tab algn="l" pos="0"/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9AB3CD-FE64-4FE9-8907-65D104A6D9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219240"/>
            <a:ext cx="4303440" cy="79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2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1098720"/>
            <a:ext cx="2099880" cy="124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548440" y="1098720"/>
            <a:ext cx="2099880" cy="2620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2467800"/>
            <a:ext cx="2099880" cy="124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75BCCD-F119-4912-B533-E869442BA1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219240"/>
            <a:ext cx="4303440" cy="79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2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1098720"/>
            <a:ext cx="2099880" cy="2620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548440" y="1098720"/>
            <a:ext cx="2099880" cy="124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548440" y="2467800"/>
            <a:ext cx="2099880" cy="124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9E5BFE-6CF9-43E9-A748-26B29B51BC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219240"/>
            <a:ext cx="4303440" cy="79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2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1098720"/>
            <a:ext cx="2099880" cy="124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548440" y="1098720"/>
            <a:ext cx="2099880" cy="124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2467800"/>
            <a:ext cx="4303440" cy="124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50"/>
              </a:spcBef>
              <a:buNone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E5FFCF-B35C-455B-9B3E-CE5780D31E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3080" y="219240"/>
            <a:ext cx="4303440" cy="79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2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3080" y="1098720"/>
            <a:ext cx="4303440" cy="2620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23840" indent="-123840">
              <a:lnSpc>
                <a:spcPct val="90000"/>
              </a:lnSpc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  <a:p>
            <a:pPr lvl="1" marL="372960" indent="-123840">
              <a:lnSpc>
                <a:spcPct val="90000"/>
              </a:lnSpc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  <a:p>
            <a:pPr lvl="2" marL="622440" indent="-123840">
              <a:lnSpc>
                <a:spcPct val="90000"/>
              </a:lnSpc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  <a:p>
            <a:pPr lvl="3" marL="873000" indent="-123840">
              <a:lnSpc>
                <a:spcPct val="90000"/>
              </a:lnSpc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  <a:p>
            <a:pPr lvl="4" marL="1122480" indent="-123840">
              <a:lnSpc>
                <a:spcPct val="90000"/>
              </a:lnSpc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  <a:p>
            <a:pPr lvl="5" marL="1122480" indent="-123840">
              <a:lnSpc>
                <a:spcPct val="90000"/>
              </a:lnSpc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  <a:p>
            <a:pPr lvl="6" marL="1122480" indent="-123840">
              <a:lnSpc>
                <a:spcPct val="90000"/>
              </a:lnSpc>
              <a:spcBef>
                <a:spcPts val="550"/>
              </a:spcBef>
              <a:buClr>
                <a:srgbClr val="000000"/>
              </a:buClr>
              <a:buFont typeface="Arial"/>
              <a:buChar char="•"/>
              <a:tabLst>
                <a:tab algn="l" pos="498600"/>
                <a:tab algn="l" pos="996840"/>
                <a:tab algn="l" pos="1495440"/>
                <a:tab algn="l" pos="1994040"/>
                <a:tab algn="l" pos="2492280"/>
                <a:tab algn="l" pos="2990880"/>
                <a:tab algn="l" pos="3489480"/>
                <a:tab algn="l" pos="3987720"/>
                <a:tab algn="l" pos="4486320"/>
                <a:tab algn="l" pos="4984920"/>
                <a:tab algn="l" pos="5483160"/>
                <a:tab algn="l" pos="5981760"/>
                <a:tab algn="l" pos="6480000"/>
                <a:tab algn="l" pos="6978600"/>
                <a:tab algn="l" pos="7477200"/>
                <a:tab algn="l" pos="7975440"/>
                <a:tab algn="l" pos="8474040"/>
                <a:tab algn="l" pos="8972640"/>
                <a:tab algn="l" pos="9470880"/>
                <a:tab algn="l" pos="996948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3827520"/>
            <a:ext cx="1122120" cy="218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6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652760" y="3827520"/>
            <a:ext cx="1684080" cy="218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524040" y="3827520"/>
            <a:ext cx="1122120" cy="218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6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D3B1A8-6747-42C5-8CA9-85C6EF9EC166}" type="slidenum">
              <a:rPr b="0" lang="en-US" sz="6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13"/>
          <p:cNvSpPr/>
          <p:nvPr/>
        </p:nvSpPr>
        <p:spPr>
          <a:xfrm>
            <a:off x="2803680" y="247680"/>
            <a:ext cx="1885680" cy="314316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87"/>
          <p:cNvSpPr/>
          <p:nvPr/>
        </p:nvSpPr>
        <p:spPr>
          <a:xfrm>
            <a:off x="2174760" y="2784600"/>
            <a:ext cx="65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-act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13"/>
          <p:cNvSpPr/>
          <p:nvPr/>
        </p:nvSpPr>
        <p:spPr>
          <a:xfrm>
            <a:off x="426960" y="3387600"/>
            <a:ext cx="19479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361800"/>
                <a:tab algn="l" pos="723960"/>
                <a:tab algn="l" pos="1085760"/>
                <a:tab algn="l" pos="1447920"/>
                <a:tab algn="l" pos="1809720"/>
                <a:tab algn="l" pos="2171880"/>
                <a:tab algn="l" pos="2533680"/>
                <a:tab algn="l" pos="2895480"/>
                <a:tab algn="l" pos="3257640"/>
                <a:tab algn="l" pos="3619440"/>
                <a:tab algn="l" pos="3981600"/>
                <a:tab algn="l" pos="4343400"/>
                <a:tab algn="l" pos="4705200"/>
                <a:tab algn="l" pos="5067360"/>
                <a:tab algn="l" pos="5429160"/>
                <a:tab algn="l" pos="5791320"/>
                <a:tab algn="l" pos="6153120"/>
                <a:tab algn="l" pos="6515280"/>
                <a:tab algn="l" pos="6877080"/>
                <a:tab algn="l" pos="72388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W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 kb ladde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361800"/>
                <a:tab algn="l" pos="723960"/>
                <a:tab algn="l" pos="1085760"/>
                <a:tab algn="l" pos="1447920"/>
                <a:tab algn="l" pos="1809720"/>
                <a:tab algn="l" pos="2171880"/>
                <a:tab algn="l" pos="2533680"/>
                <a:tab algn="l" pos="2895480"/>
                <a:tab algn="l" pos="3257640"/>
                <a:tab algn="l" pos="3619440"/>
                <a:tab algn="l" pos="3981600"/>
                <a:tab algn="l" pos="4343400"/>
                <a:tab algn="l" pos="4705200"/>
                <a:tab algn="l" pos="5067360"/>
                <a:tab algn="l" pos="5429160"/>
                <a:tab algn="l" pos="5791320"/>
                <a:tab algn="l" pos="6153120"/>
                <a:tab algn="l" pos="6515280"/>
                <a:tab algn="l" pos="6877080"/>
                <a:tab algn="l" pos="72388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 cell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361800"/>
                <a:tab algn="l" pos="723960"/>
                <a:tab algn="l" pos="1085760"/>
                <a:tab algn="l" pos="1447920"/>
                <a:tab algn="l" pos="1809720"/>
                <a:tab algn="l" pos="2171880"/>
                <a:tab algn="l" pos="2533680"/>
                <a:tab algn="l" pos="2895480"/>
                <a:tab algn="l" pos="3257640"/>
                <a:tab algn="l" pos="3619440"/>
                <a:tab algn="l" pos="3981600"/>
                <a:tab algn="l" pos="4343400"/>
                <a:tab algn="l" pos="4705200"/>
                <a:tab algn="l" pos="5067360"/>
                <a:tab algn="l" pos="5429160"/>
                <a:tab algn="l" pos="5791320"/>
                <a:tab algn="l" pos="6153120"/>
                <a:tab algn="l" pos="6515280"/>
                <a:tab algn="l" pos="6877080"/>
                <a:tab algn="l" pos="723888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: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CA1-KO cell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43"/>
          <p:cNvSpPr/>
          <p:nvPr/>
        </p:nvSpPr>
        <p:spPr>
          <a:xfrm>
            <a:off x="152280" y="-42840"/>
            <a:ext cx="506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43"/>
          <p:cNvSpPr/>
          <p:nvPr/>
        </p:nvSpPr>
        <p:spPr>
          <a:xfrm>
            <a:off x="1832040" y="-42840"/>
            <a:ext cx="506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86"/>
          <p:cNvSpPr/>
          <p:nvPr/>
        </p:nvSpPr>
        <p:spPr>
          <a:xfrm>
            <a:off x="1909800" y="743040"/>
            <a:ext cx="923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CA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b191042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86"/>
          <p:cNvSpPr/>
          <p:nvPr/>
        </p:nvSpPr>
        <p:spPr>
          <a:xfrm>
            <a:off x="1936800" y="1847880"/>
            <a:ext cx="8967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CA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b131360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5" name="Groupe 14"/>
          <p:cNvGrpSpPr/>
          <p:nvPr/>
        </p:nvGrpSpPr>
        <p:grpSpPr>
          <a:xfrm>
            <a:off x="2820960" y="268200"/>
            <a:ext cx="1851120" cy="3097440"/>
            <a:chOff x="2820960" y="268200"/>
            <a:chExt cx="1851120" cy="3097440"/>
          </a:xfrm>
        </p:grpSpPr>
        <p:pic>
          <p:nvPicPr>
            <p:cNvPr id="56" name="Image 8" descr=""/>
            <p:cNvPicPr/>
            <p:nvPr/>
          </p:nvPicPr>
          <p:blipFill>
            <a:blip r:embed="rId1"/>
            <a:stretch/>
          </p:blipFill>
          <p:spPr>
            <a:xfrm>
              <a:off x="2820960" y="1380600"/>
              <a:ext cx="1851120" cy="1042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Image 9" descr=""/>
            <p:cNvPicPr/>
            <p:nvPr/>
          </p:nvPicPr>
          <p:blipFill>
            <a:blip r:embed="rId2"/>
            <a:stretch/>
          </p:blipFill>
          <p:spPr>
            <a:xfrm>
              <a:off x="2820960" y="268200"/>
              <a:ext cx="1851120" cy="1075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Image 12" descr=""/>
            <p:cNvPicPr/>
            <p:nvPr/>
          </p:nvPicPr>
          <p:blipFill>
            <a:blip r:embed="rId3"/>
            <a:stretch/>
          </p:blipFill>
          <p:spPr>
            <a:xfrm>
              <a:off x="2820960" y="2464560"/>
              <a:ext cx="1851120" cy="901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9" name="ZoneTexte 1"/>
            <p:cNvSpPr/>
            <p:nvPr/>
          </p:nvSpPr>
          <p:spPr>
            <a:xfrm>
              <a:off x="3293640" y="808560"/>
              <a:ext cx="250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ff0000"/>
                  </a:solidFill>
                  <a:latin typeface="Calibri"/>
                </a:rPr>
                <a:t>*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ZoneTexte 1"/>
            <p:cNvSpPr/>
            <p:nvPr/>
          </p:nvSpPr>
          <p:spPr>
            <a:xfrm>
              <a:off x="3333240" y="1904400"/>
              <a:ext cx="250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100" spc="-1" strike="noStrike">
                  <a:solidFill>
                    <a:srgbClr val="ff0000"/>
                  </a:solidFill>
                  <a:latin typeface="Calibri"/>
                </a:rPr>
                <a:t>*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1" name="TextBox 91"/>
          <p:cNvSpPr/>
          <p:nvPr/>
        </p:nvSpPr>
        <p:spPr>
          <a:xfrm>
            <a:off x="2984400" y="264960"/>
            <a:ext cx="30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91"/>
          <p:cNvSpPr/>
          <p:nvPr/>
        </p:nvSpPr>
        <p:spPr>
          <a:xfrm>
            <a:off x="3606840" y="264960"/>
            <a:ext cx="30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91"/>
          <p:cNvSpPr/>
          <p:nvPr/>
        </p:nvSpPr>
        <p:spPr>
          <a:xfrm>
            <a:off x="4238640" y="264960"/>
            <a:ext cx="30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91"/>
          <p:cNvSpPr/>
          <p:nvPr/>
        </p:nvSpPr>
        <p:spPr>
          <a:xfrm>
            <a:off x="2538360" y="3389400"/>
            <a:ext cx="22478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228600" indent="-22860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 cell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228600" indent="-22860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CA1-KO cells (sample 1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marL="228600" indent="-228600">
              <a:lnSpc>
                <a:spcPct val="100000"/>
              </a:lnSpc>
              <a:buClr>
                <a:srgbClr val="000000"/>
              </a:buClr>
              <a:buFont typeface="Times New Roman"/>
              <a:buAutoNum type="arabicPeriod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CA1-KO cells (sample 2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5" name="Image 1" descr=""/>
          <p:cNvPicPr/>
          <p:nvPr/>
        </p:nvPicPr>
        <p:blipFill>
          <a:blip r:embed="rId4"/>
          <a:stretch/>
        </p:blipFill>
        <p:spPr>
          <a:xfrm>
            <a:off x="523800" y="274680"/>
            <a:ext cx="873360" cy="3092400"/>
          </a:xfrm>
          <a:prstGeom prst="rect">
            <a:avLst/>
          </a:prstGeom>
          <a:ln w="0">
            <a:noFill/>
          </a:ln>
        </p:spPr>
      </p:pic>
      <p:sp>
        <p:nvSpPr>
          <p:cNvPr id="66" name="TextBox 3"/>
          <p:cNvSpPr/>
          <p:nvPr/>
        </p:nvSpPr>
        <p:spPr>
          <a:xfrm>
            <a:off x="446040" y="573120"/>
            <a:ext cx="646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W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91"/>
          <p:cNvSpPr/>
          <p:nvPr/>
        </p:nvSpPr>
        <p:spPr>
          <a:xfrm>
            <a:off x="795240" y="573120"/>
            <a:ext cx="30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93"/>
          <p:cNvSpPr/>
          <p:nvPr/>
        </p:nvSpPr>
        <p:spPr>
          <a:xfrm>
            <a:off x="1062000" y="573120"/>
            <a:ext cx="30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ZoneTexte 1"/>
          <p:cNvSpPr/>
          <p:nvPr/>
        </p:nvSpPr>
        <p:spPr>
          <a:xfrm>
            <a:off x="1215720" y="1782720"/>
            <a:ext cx="212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100" spc="-1" strike="noStrike">
                <a:solidFill>
                  <a:srgbClr val="ff0000"/>
                </a:solidFill>
                <a:latin typeface="Calibri"/>
              </a:rPr>
              <a:t>i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ZoneTexte 30"/>
          <p:cNvSpPr/>
          <p:nvPr/>
        </p:nvSpPr>
        <p:spPr>
          <a:xfrm>
            <a:off x="1199880" y="1978200"/>
            <a:ext cx="244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100" spc="-1" strike="noStrike">
                <a:solidFill>
                  <a:srgbClr val="ff0000"/>
                </a:solidFill>
                <a:latin typeface="Calibri"/>
              </a:rPr>
              <a:t>ii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ZoneTexte 31"/>
          <p:cNvSpPr/>
          <p:nvPr/>
        </p:nvSpPr>
        <p:spPr>
          <a:xfrm>
            <a:off x="1203840" y="2651040"/>
            <a:ext cx="276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100" spc="-1" strike="noStrike">
                <a:solidFill>
                  <a:srgbClr val="ff0000"/>
                </a:solidFill>
                <a:latin typeface="Calibri"/>
              </a:rPr>
              <a:t>iii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9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1-25T22:20:47Z</dcterms:created>
  <dc:creator>Dana Hamam</dc:creator>
  <dc:description/>
  <dc:language>en-US</dc:language>
  <cp:lastModifiedBy>MOHAMED ABDOUH</cp:lastModifiedBy>
  <dcterms:modified xsi:type="dcterms:W3CDTF">2016-05-04T17:01:15Z</dcterms:modified>
  <cp:revision>80</cp:revision>
  <dc:subject/>
  <dc:title>PowerPoint Presentation</dc:title>
</cp:coreProperties>
</file>